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9" r:id="rId2"/>
    <p:sldId id="260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95"/>
    <p:restoredTop sz="94718"/>
  </p:normalViewPr>
  <p:slideViewPr>
    <p:cSldViewPr snapToGrid="0" snapToObjects="1">
      <p:cViewPr varScale="1">
        <p:scale>
          <a:sx n="87" d="100"/>
          <a:sy n="87" d="100"/>
        </p:scale>
        <p:origin x="16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A3C9A7-4553-F645-825F-03F7A5B186EA}" type="datetimeFigureOut">
              <a:rPr lang="en-US" smtClean="0"/>
              <a:t>6/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98C28D-C9A6-F644-A42E-4953766C74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805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171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862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534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383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085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633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639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226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781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063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508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E9F145-2897-1649-9BF0-9F7C4ACC39E1}" type="datetimeFigureOut">
              <a:rPr lang="en-US" smtClean="0"/>
              <a:t>6/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2B518-85AA-8349-8D29-1D18B15813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184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8BCCC77-775F-461B-ABC1-BEFB3DD8D349}"/>
              </a:ext>
            </a:extLst>
          </p:cNvPr>
          <p:cNvSpPr txBox="1"/>
          <p:nvPr/>
        </p:nvSpPr>
        <p:spPr>
          <a:xfrm>
            <a:off x="377806" y="1296382"/>
            <a:ext cx="21210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enetically defined immunodeficienc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C0364A9-669F-D534-49C2-4ABAE189C9C6}"/>
              </a:ext>
            </a:extLst>
          </p:cNvPr>
          <p:cNvSpPr txBox="1"/>
          <p:nvPr/>
        </p:nvSpPr>
        <p:spPr>
          <a:xfrm>
            <a:off x="1923100" y="2043838"/>
            <a:ext cx="5757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besity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501C5E8-15C2-7675-2A2B-FE8C5315C90A}"/>
              </a:ext>
            </a:extLst>
          </p:cNvPr>
          <p:cNvSpPr txBox="1"/>
          <p:nvPr/>
        </p:nvSpPr>
        <p:spPr>
          <a:xfrm>
            <a:off x="961299" y="2540347"/>
            <a:ext cx="15376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o. of COVID-19 vaccin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4C9B8AC-2304-D0BC-6572-045C2C2096BD}"/>
              </a:ext>
            </a:extLst>
          </p:cNvPr>
          <p:cNvSpPr txBox="1"/>
          <p:nvPr/>
        </p:nvSpPr>
        <p:spPr>
          <a:xfrm>
            <a:off x="588002" y="2705767"/>
            <a:ext cx="19287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nfection after December 31, 202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1AD5061-6B4F-D6DB-7775-516E535406C0}"/>
              </a:ext>
            </a:extLst>
          </p:cNvPr>
          <p:cNvSpPr txBox="1"/>
          <p:nvPr/>
        </p:nvSpPr>
        <p:spPr>
          <a:xfrm>
            <a:off x="2128285" y="1123685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VI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792098-A95C-F18F-EA61-FD7AAE5B4CC9}"/>
              </a:ext>
            </a:extLst>
          </p:cNvPr>
          <p:cNvSpPr txBox="1"/>
          <p:nvPr/>
        </p:nvSpPr>
        <p:spPr>
          <a:xfrm>
            <a:off x="2109049" y="950988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0F04B34-69A6-1B22-6953-2041765230D9}"/>
              </a:ext>
            </a:extLst>
          </p:cNvPr>
          <p:cNvSpPr txBox="1"/>
          <p:nvPr/>
        </p:nvSpPr>
        <p:spPr>
          <a:xfrm>
            <a:off x="1692268" y="1798571"/>
            <a:ext cx="8066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 cell defec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BC4F289-A08F-75C2-C140-3C9D7748D431}"/>
              </a:ext>
            </a:extLst>
          </p:cNvPr>
          <p:cNvSpPr txBox="1"/>
          <p:nvPr/>
        </p:nvSpPr>
        <p:spPr>
          <a:xfrm>
            <a:off x="833058" y="2209341"/>
            <a:ext cx="16658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istory of neurologic diseas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44E4360-1070-481F-9327-53E2903C1FF3}"/>
              </a:ext>
            </a:extLst>
          </p:cNvPr>
          <p:cNvSpPr txBox="1"/>
          <p:nvPr/>
        </p:nvSpPr>
        <p:spPr>
          <a:xfrm>
            <a:off x="1108775" y="2374844"/>
            <a:ext cx="139012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istory of renal diseas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2718559-7DDC-B767-BBD6-26BE7B88B898}"/>
              </a:ext>
            </a:extLst>
          </p:cNvPr>
          <p:cNvSpPr txBox="1"/>
          <p:nvPr/>
        </p:nvSpPr>
        <p:spPr>
          <a:xfrm>
            <a:off x="504964" y="1469079"/>
            <a:ext cx="19992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istory of B cell-depleting therapie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5A49F3C-AD4C-9312-F10E-FB47846779D3}"/>
              </a:ext>
            </a:extLst>
          </p:cNvPr>
          <p:cNvSpPr txBox="1"/>
          <p:nvPr/>
        </p:nvSpPr>
        <p:spPr>
          <a:xfrm>
            <a:off x="594428" y="2860981"/>
            <a:ext cx="19287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reatment with SARS-CoV-2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mAb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B522A69-DD93-CACD-308A-B46424616237}"/>
              </a:ext>
            </a:extLst>
          </p:cNvPr>
          <p:cNvSpPr txBox="1"/>
          <p:nvPr/>
        </p:nvSpPr>
        <p:spPr>
          <a:xfrm>
            <a:off x="555942" y="774215"/>
            <a:ext cx="196079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nderrepresented race or ethnicit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26BAEF9-F15F-3774-23F3-E62AA1C9AAD0}"/>
              </a:ext>
            </a:extLst>
          </p:cNvPr>
          <p:cNvSpPr txBox="1"/>
          <p:nvPr/>
        </p:nvSpPr>
        <p:spPr>
          <a:xfrm>
            <a:off x="4174922" y="573057"/>
            <a:ext cx="21804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dds Ratio (95% CI); adj. </a:t>
            </a:r>
            <a:r>
              <a:rPr 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valu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512803D-027C-47BD-CC95-EBC13BA46595}"/>
              </a:ext>
            </a:extLst>
          </p:cNvPr>
          <p:cNvSpPr txBox="1"/>
          <p:nvPr/>
        </p:nvSpPr>
        <p:spPr>
          <a:xfrm>
            <a:off x="4235395" y="789905"/>
            <a:ext cx="189827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.74 (1.98 – 23.0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2.0 x 10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5259B98-3F39-312C-FC4C-763533EE6E9F}"/>
              </a:ext>
            </a:extLst>
          </p:cNvPr>
          <p:cNvSpPr txBox="1"/>
          <p:nvPr/>
        </p:nvSpPr>
        <p:spPr>
          <a:xfrm>
            <a:off x="4235395" y="1790258"/>
            <a:ext cx="15792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98 (0.28 – 3.45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0.9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766B2CA-801C-DE66-A4F3-F1A996E201FD}"/>
              </a:ext>
            </a:extLst>
          </p:cNvPr>
          <p:cNvSpPr txBox="1"/>
          <p:nvPr/>
        </p:nvSpPr>
        <p:spPr>
          <a:xfrm>
            <a:off x="4235395" y="950988"/>
            <a:ext cx="18341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06 (1.01 – 1.10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9.0 x 10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B8F0AC8-7464-DF73-2BB3-30E64E4525F8}"/>
              </a:ext>
            </a:extLst>
          </p:cNvPr>
          <p:cNvSpPr txBox="1"/>
          <p:nvPr/>
        </p:nvSpPr>
        <p:spPr>
          <a:xfrm>
            <a:off x="4235395" y="1123685"/>
            <a:ext cx="15792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3.20 (0.22 – 46.4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0.4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96652A4-BE4F-2331-46FE-FA2F85DFD593}"/>
              </a:ext>
            </a:extLst>
          </p:cNvPr>
          <p:cNvSpPr txBox="1"/>
          <p:nvPr/>
        </p:nvSpPr>
        <p:spPr>
          <a:xfrm>
            <a:off x="4235395" y="1296382"/>
            <a:ext cx="18341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.05 (1.81 – 20.2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3.0 x 10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17B7E4F-4091-9FD3-D2D2-B5D95CCD28CC}"/>
              </a:ext>
            </a:extLst>
          </p:cNvPr>
          <p:cNvSpPr txBox="1"/>
          <p:nvPr/>
        </p:nvSpPr>
        <p:spPr>
          <a:xfrm>
            <a:off x="4235395" y="1617923"/>
            <a:ext cx="15792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.04 (0.33 – 3.29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0.95</a:t>
            </a:r>
            <a:endParaRPr 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9977AC1-35AD-C362-4CF4-505D16421BE2}"/>
              </a:ext>
            </a:extLst>
          </p:cNvPr>
          <p:cNvSpPr txBox="1"/>
          <p:nvPr/>
        </p:nvSpPr>
        <p:spPr>
          <a:xfrm>
            <a:off x="4235395" y="2043838"/>
            <a:ext cx="18341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.62 (1.29 – 16.6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1.9 x 10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840B990-88B0-A5A0-ADA1-3AE8B784361E}"/>
              </a:ext>
            </a:extLst>
          </p:cNvPr>
          <p:cNvSpPr txBox="1"/>
          <p:nvPr/>
        </p:nvSpPr>
        <p:spPr>
          <a:xfrm>
            <a:off x="4235395" y="2209341"/>
            <a:ext cx="18341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6.71 (1.84 – 24.5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4.0 x 10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8135456-3F5D-E907-B12D-830E60A59004}"/>
              </a:ext>
            </a:extLst>
          </p:cNvPr>
          <p:cNvSpPr txBox="1"/>
          <p:nvPr/>
        </p:nvSpPr>
        <p:spPr>
          <a:xfrm>
            <a:off x="4235395" y="2383157"/>
            <a:ext cx="15792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4.56 (0.25 – 83.8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0.3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8F7F3B4-1D02-92D4-1B76-DE071D519C87}"/>
              </a:ext>
            </a:extLst>
          </p:cNvPr>
          <p:cNvSpPr txBox="1"/>
          <p:nvPr/>
        </p:nvSpPr>
        <p:spPr>
          <a:xfrm>
            <a:off x="4235395" y="2701811"/>
            <a:ext cx="16433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.82 (0.96 – 8.31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0.06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F854877-D0CB-8116-1638-5DD7E49F62B7}"/>
              </a:ext>
            </a:extLst>
          </p:cNvPr>
          <p:cNvSpPr txBox="1"/>
          <p:nvPr/>
        </p:nvSpPr>
        <p:spPr>
          <a:xfrm>
            <a:off x="4235395" y="2874508"/>
            <a:ext cx="15792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46( 0.11 – 1.91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0.29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F7094FC-8F57-4FB5-037D-0FCD20EB8115}"/>
              </a:ext>
            </a:extLst>
          </p:cNvPr>
          <p:cNvSpPr txBox="1"/>
          <p:nvPr/>
        </p:nvSpPr>
        <p:spPr>
          <a:xfrm>
            <a:off x="1175552" y="573057"/>
            <a:ext cx="10358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haracteristi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61A9A57-FAFC-8DBC-0248-33A50932E5AA}"/>
              </a:ext>
            </a:extLst>
          </p:cNvPr>
          <p:cNvSpPr txBox="1"/>
          <p:nvPr/>
        </p:nvSpPr>
        <p:spPr>
          <a:xfrm>
            <a:off x="2270724" y="3125979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F9B8DD7-FF1E-C10B-3CB7-904CBA6E3C3B}"/>
              </a:ext>
            </a:extLst>
          </p:cNvPr>
          <p:cNvSpPr txBox="1"/>
          <p:nvPr/>
        </p:nvSpPr>
        <p:spPr>
          <a:xfrm>
            <a:off x="2899349" y="3125979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5417EF8-6178-3286-C1DE-107EB27D923E}"/>
              </a:ext>
            </a:extLst>
          </p:cNvPr>
          <p:cNvSpPr txBox="1"/>
          <p:nvPr/>
        </p:nvSpPr>
        <p:spPr>
          <a:xfrm>
            <a:off x="3473933" y="312597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E0A7016-2F2F-CCBD-D8DD-526D4F7A765A}"/>
              </a:ext>
            </a:extLst>
          </p:cNvPr>
          <p:cNvSpPr txBox="1"/>
          <p:nvPr/>
        </p:nvSpPr>
        <p:spPr>
          <a:xfrm>
            <a:off x="4077402" y="3125979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CA8AE46-4FF4-5827-ECA4-F92358B558FF}"/>
              </a:ext>
            </a:extLst>
          </p:cNvPr>
          <p:cNvSpPr txBox="1"/>
          <p:nvPr/>
        </p:nvSpPr>
        <p:spPr>
          <a:xfrm>
            <a:off x="2948120" y="3318105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dds Ratio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4099BC3-4C44-1E32-BA7E-1DA72568788C}"/>
              </a:ext>
            </a:extLst>
          </p:cNvPr>
          <p:cNvSpPr txBox="1"/>
          <p:nvPr/>
        </p:nvSpPr>
        <p:spPr>
          <a:xfrm>
            <a:off x="1166483" y="1617923"/>
            <a:ext cx="133241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nd organ dysfunction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5479622-1DEE-DE39-424F-708148B90EA3}"/>
              </a:ext>
            </a:extLst>
          </p:cNvPr>
          <p:cNvSpPr txBox="1"/>
          <p:nvPr/>
        </p:nvSpPr>
        <p:spPr>
          <a:xfrm>
            <a:off x="4235395" y="1469079"/>
            <a:ext cx="16754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.15 (1.17 – 60.0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0.034 </a:t>
            </a:r>
            <a:endParaRPr lang="en-US" sz="9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E45B186-FCAD-5144-BEF8-A32E3E3D97AD}"/>
              </a:ext>
            </a:extLst>
          </p:cNvPr>
          <p:cNvSpPr txBox="1"/>
          <p:nvPr/>
        </p:nvSpPr>
        <p:spPr>
          <a:xfrm>
            <a:off x="66261" y="92765"/>
            <a:ext cx="66081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E1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10110AEF-9D98-2649-8B9F-7F03D77723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5091" y="754160"/>
            <a:ext cx="1955800" cy="242570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356AA3F3-E46F-EC4C-874E-684728CDE08B}"/>
              </a:ext>
            </a:extLst>
          </p:cNvPr>
          <p:cNvSpPr txBox="1"/>
          <p:nvPr/>
        </p:nvSpPr>
        <p:spPr>
          <a:xfrm>
            <a:off x="4235395" y="2540347"/>
            <a:ext cx="18341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.46 (0.27 – 0.78);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= 4.0 x 10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</p:spTree>
    <p:extLst>
      <p:ext uri="{BB962C8B-B14F-4D97-AF65-F5344CB8AC3E}">
        <p14:creationId xmlns:p14="http://schemas.microsoft.com/office/powerpoint/2010/main" val="8644117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4153023-CA6C-4449-B672-0BAC765CCB66}"/>
              </a:ext>
            </a:extLst>
          </p:cNvPr>
          <p:cNvSpPr txBox="1"/>
          <p:nvPr/>
        </p:nvSpPr>
        <p:spPr>
          <a:xfrm>
            <a:off x="288076" y="283396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E2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BAE5164-7813-9547-A463-C543D2555DAB}"/>
              </a:ext>
            </a:extLst>
          </p:cNvPr>
          <p:cNvSpPr txBox="1"/>
          <p:nvPr/>
        </p:nvSpPr>
        <p:spPr>
          <a:xfrm>
            <a:off x="4103973" y="1852532"/>
            <a:ext cx="2332690" cy="39703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ospitalized (n=20)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mbined Immunodeficiency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22q11.2 deletion (n=2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D40L (n=2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NMT1 deficiency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TAT5b deficiency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risomy 21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XIAP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umoral Immunodeficiency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TK (n=2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OG4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KMT2D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FKB1 (n=2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FKB2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HANK3 deficiency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nate Immunodeficiency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CF2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LRP12 (n=2)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IRD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OCS1</a:t>
            </a:r>
          </a:p>
          <a:p>
            <a:pPr algn="ctr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D4CDA9F-B0FB-F240-BB98-B4AC7386CD71}"/>
              </a:ext>
            </a:extLst>
          </p:cNvPr>
          <p:cNvSpPr txBox="1"/>
          <p:nvPr/>
        </p:nvSpPr>
        <p:spPr>
          <a:xfrm>
            <a:off x="0" y="1852532"/>
            <a:ext cx="3359318" cy="56323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utpatient  (n=46)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mbined Immunodeficiency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22q11.2 deletion (n=9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TM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OCK2 (n=4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FOXN1 AR disease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IL2RG (n=2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risomy 21 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WAS (n=3)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umoral Immunodeficiency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TK (n=5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h 5 deletion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10q23.1-q23.31 deletion (BMPR1A and PTEN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IRF2BPP2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KMT2D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I3KD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RPL35A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NFRSF13B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risomy 21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nate Immunodeficiency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IFNGR1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CF2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NLRP3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STPIP2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IRD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OPA Syndrome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CTLA4 (n=3)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</a:p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TAT3 GOF (n=2)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D9338F3B-5F44-6841-856C-C2E564E973EE}"/>
              </a:ext>
            </a:extLst>
          </p:cNvPr>
          <p:cNvCxnSpPr>
            <a:cxnSpLocks/>
            <a:stCxn id="3" idx="2"/>
            <a:endCxn id="6" idx="0"/>
          </p:cNvCxnSpPr>
          <p:nvPr/>
        </p:nvCxnSpPr>
        <p:spPr>
          <a:xfrm flipH="1">
            <a:off x="1679659" y="1304034"/>
            <a:ext cx="1899961" cy="548498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A6D9208-4D5F-DF49-AB87-92F4297BC35B}"/>
              </a:ext>
            </a:extLst>
          </p:cNvPr>
          <p:cNvCxnSpPr>
            <a:cxnSpLocks/>
            <a:stCxn id="3" idx="2"/>
            <a:endCxn id="5" idx="0"/>
          </p:cNvCxnSpPr>
          <p:nvPr/>
        </p:nvCxnSpPr>
        <p:spPr>
          <a:xfrm>
            <a:off x="3579620" y="1304034"/>
            <a:ext cx="1690698" cy="548498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0F28FD0C-2495-14E0-2B6E-04B7A0ED1F2E}"/>
              </a:ext>
            </a:extLst>
          </p:cNvPr>
          <p:cNvSpPr txBox="1"/>
          <p:nvPr/>
        </p:nvSpPr>
        <p:spPr>
          <a:xfrm>
            <a:off x="1863362" y="780814"/>
            <a:ext cx="343251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atients with Genetic Diagnoses (n=66)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8325141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9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4</TotalTime>
  <Words>352</Words>
  <Application>Microsoft Macintosh PowerPoint</Application>
  <PresentationFormat>Letter Paper (8.5x11 in)</PresentationFormat>
  <Paragraphs>8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Chou</dc:creator>
  <cp:lastModifiedBy>Brenna Labere</cp:lastModifiedBy>
  <cp:revision>72</cp:revision>
  <dcterms:created xsi:type="dcterms:W3CDTF">2022-05-29T16:15:47Z</dcterms:created>
  <dcterms:modified xsi:type="dcterms:W3CDTF">2023-06-01T20:16:46Z</dcterms:modified>
</cp:coreProperties>
</file>